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9" r:id="rId3"/>
    <p:sldId id="427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2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F39993-AB9A-4718-9964-7E1669C721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4F62880-3D4E-42BC-B574-870DDDE3CFA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0E7E4B-B2C9-4F6F-87AD-3A81706DFE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619D-F7BC-45F3-BB9E-4A646F8D2DDA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CE9B15-2943-49BC-B403-D98C8CD86C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E2D86C-746B-4EFE-A187-123165B63F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1A95-194B-4981-A29E-CFC845118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485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6E755A-46EE-496F-8515-77CC4516BE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1D26571-F783-48AC-9B8E-3FDF60EB93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DE7BD5-1F47-47DF-B15D-4069B3ABFF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619D-F7BC-45F3-BB9E-4A646F8D2DDA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F7505B-F27C-4371-B023-CC0CD95271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1702E-D087-4C0A-8712-EC7F5112F1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1A95-194B-4981-A29E-CFC845118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8950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F007982-1DCA-41E3-9247-702517459BD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9088D1-6FBE-415D-9C99-DBA87CB2C4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9D1DBA-A7DE-4522-A939-376FA2701C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619D-F7BC-45F3-BB9E-4A646F8D2DDA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C4A5034-0022-4A89-A56E-98FEF501DE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5C4CB7-A027-4FE7-BA7C-E440505DE2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1A95-194B-4981-A29E-CFC845118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572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7E999B-6F34-48D3-A2C0-059FEBE5C2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A9405D-8AE2-47FC-A5CB-EDBFE9707BB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82BF14-D7C7-47FF-9654-B94868360A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619D-F7BC-45F3-BB9E-4A646F8D2DDA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0AE962-C57F-4DF5-BB40-6AE4BC400E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66F9FBB-969A-4FDC-BAC6-C66256AF47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1A95-194B-4981-A29E-CFC845118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4614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C3CD6E-C197-4EC0-8251-D8A474611B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6550C1B-92D7-4B17-991D-5238E3D167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554EAC-CE26-43F0-8AB5-01CBA982EA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619D-F7BC-45F3-BB9E-4A646F8D2DDA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CF09D3-CD9A-4953-B4E3-6D38BBDE53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EA75B4-C6A9-4FBA-96D0-63C2C45153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1A95-194B-4981-A29E-CFC845118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37792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FC453A-E645-4ECC-935F-F3E7C04F4F3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A2C716-A094-4659-94FF-31B2E21232B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1B59317-10F7-4352-9F2A-D0F766D8AB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D5D14F-5076-4033-908D-901C1430DB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619D-F7BC-45F3-BB9E-4A646F8D2DDA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5DCCB1-717A-4E88-AF2A-2778AA985F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AF4C79-E0D8-45C6-995C-05D6F0564C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1A95-194B-4981-A29E-CFC845118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6372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5364CA-D292-499E-82C1-6F6B225755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CC9B36-1DB9-4293-A091-73F1521A6D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EE6CCE-3C46-44D8-B94F-83B788BEF32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9B1E786-FD8D-40DA-8A2F-7D09D431739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31D04A6-06B1-4341-A329-73304A1C8C1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89CE4B0-F7E5-435C-8616-EE1AAB67B3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619D-F7BC-45F3-BB9E-4A646F8D2DDA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CFE263D-F8C2-41AD-AA58-F4900EAD6C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9B7C7BF-0D09-430C-88E2-DF707011F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1A95-194B-4981-A29E-CFC845118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8622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75765C-542C-4804-9CE6-70DC5A0908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007BF76-4F78-40E1-800F-DF9B94C2E2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619D-F7BC-45F3-BB9E-4A646F8D2DDA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AD64A4A-34EC-4BC1-A119-D0AD70158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C2A4DC0-09E6-418E-AC0C-C1F89061B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1A95-194B-4981-A29E-CFC845118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48074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CB0AAE4-2442-4107-8622-3BB49D3EBF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619D-F7BC-45F3-BB9E-4A646F8D2DDA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308C4E0-08C6-484A-9AE9-5B024F1440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AA341EB-516C-4FEF-8362-556E684EA4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1A95-194B-4981-A29E-CFC845118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730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5300F6-E869-4129-8C82-E9DCB825A9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F4C3B8-5331-4477-8C08-B134495F3BD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9CEA141-A58E-493D-ADDE-5326AAF3673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0EDD91-9026-4590-82FE-EB5AB7F833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619D-F7BC-45F3-BB9E-4A646F8D2DDA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2632C3-41C9-46AB-AA7C-440592C9B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FFF16A1-002C-47DE-B71C-962C48A506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1A95-194B-4981-A29E-CFC845118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1037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503A94-9452-4426-BBFB-C1DC52A654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2EFD4DC-AC67-4990-AA70-BE69B823463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9442B66-9392-455A-A677-8AEB4DF549E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CEC2D9-D33E-4065-8EF6-D0DC99F84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81619D-F7BC-45F3-BB9E-4A646F8D2DDA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6FE073-7CE0-4CBA-919D-810DE8F78E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42EFC9-6382-463B-9415-3897FD17C3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551A95-194B-4981-A29E-CFC845118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2424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1472368-E6EC-49D0-9A0C-CE8A2295EC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FC1421-06A1-4095-882A-EC46217618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C6E954-3F5B-4CD9-A3A1-9FA4535F4CF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81619D-F7BC-45F3-BB9E-4A646F8D2DDA}" type="datetimeFigureOut">
              <a:rPr lang="en-US" smtClean="0"/>
              <a:t>5/1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086031-31EB-41B2-90CB-358CBD5638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3D6417-A7CB-43A0-A0F3-1C377751951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551A95-194B-4981-A29E-CFC8451181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3950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" name="Group 21">
            <a:extLst>
              <a:ext uri="{FF2B5EF4-FFF2-40B4-BE49-F238E27FC236}">
                <a16:creationId xmlns:a16="http://schemas.microsoft.com/office/drawing/2014/main" id="{24F1B278-B152-4A53-A1D0-D1B417635AE1}"/>
              </a:ext>
            </a:extLst>
          </p:cNvPr>
          <p:cNvGrpSpPr/>
          <p:nvPr/>
        </p:nvGrpSpPr>
        <p:grpSpPr>
          <a:xfrm>
            <a:off x="1573793" y="273624"/>
            <a:ext cx="9044412" cy="6460294"/>
            <a:chOff x="1573793" y="273624"/>
            <a:chExt cx="9044412" cy="6460294"/>
          </a:xfrm>
        </p:grpSpPr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C57EB8AD-556B-4F66-A893-F28888465B8D}"/>
                </a:ext>
              </a:extLst>
            </p:cNvPr>
            <p:cNvGrpSpPr/>
            <p:nvPr/>
          </p:nvGrpSpPr>
          <p:grpSpPr>
            <a:xfrm>
              <a:off x="1573793" y="273624"/>
              <a:ext cx="9044412" cy="6460294"/>
              <a:chOff x="1573793" y="273624"/>
              <a:chExt cx="9044412" cy="6460294"/>
            </a:xfrm>
          </p:grpSpPr>
          <p:grpSp>
            <p:nvGrpSpPr>
              <p:cNvPr id="4" name="Group 3">
                <a:extLst>
                  <a:ext uri="{FF2B5EF4-FFF2-40B4-BE49-F238E27FC236}">
                    <a16:creationId xmlns:a16="http://schemas.microsoft.com/office/drawing/2014/main" id="{670D4B85-3AD5-4728-B576-79BEA4163FBC}"/>
                  </a:ext>
                </a:extLst>
              </p:cNvPr>
              <p:cNvGrpSpPr/>
              <p:nvPr/>
            </p:nvGrpSpPr>
            <p:grpSpPr>
              <a:xfrm>
                <a:off x="1573793" y="273624"/>
                <a:ext cx="9044412" cy="6460294"/>
                <a:chOff x="1573793" y="273624"/>
                <a:chExt cx="9044412" cy="6460294"/>
              </a:xfrm>
            </p:grpSpPr>
            <p:pic>
              <p:nvPicPr>
                <p:cNvPr id="5" name="Picture 4" descr="Proteins Quantified in each SampleSet">
                  <a:extLst>
                    <a:ext uri="{FF2B5EF4-FFF2-40B4-BE49-F238E27FC236}">
                      <a16:creationId xmlns:a16="http://schemas.microsoft.com/office/drawing/2014/main" id="{5235651E-4345-4F2E-AA6F-E8EE588C8233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573794" y="273624"/>
                  <a:ext cx="9044411" cy="6460294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16793EDB-3E8B-4ADD-89B5-ED3CB6571C8E}"/>
                    </a:ext>
                  </a:extLst>
                </p:cNvPr>
                <p:cNvSpPr txBox="1"/>
                <p:nvPr/>
              </p:nvSpPr>
              <p:spPr>
                <a:xfrm>
                  <a:off x="3704770" y="4757126"/>
                  <a:ext cx="486982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MG</a:t>
                  </a:r>
                </a:p>
              </p:txBody>
            </p:sp>
            <p:sp>
              <p:nvSpPr>
                <p:cNvPr id="7" name="TextBox 6">
                  <a:extLst>
                    <a:ext uri="{FF2B5EF4-FFF2-40B4-BE49-F238E27FC236}">
                      <a16:creationId xmlns:a16="http://schemas.microsoft.com/office/drawing/2014/main" id="{2FE76706-87C4-4329-89C5-8002E62B8478}"/>
                    </a:ext>
                  </a:extLst>
                </p:cNvPr>
                <p:cNvSpPr txBox="1"/>
                <p:nvPr/>
              </p:nvSpPr>
              <p:spPr>
                <a:xfrm>
                  <a:off x="3704770" y="4981004"/>
                  <a:ext cx="486983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YP</a:t>
                  </a:r>
                </a:p>
              </p:txBody>
            </p:sp>
            <p:sp>
              <p:nvSpPr>
                <p:cNvPr id="8" name="TextBox 7">
                  <a:extLst>
                    <a:ext uri="{FF2B5EF4-FFF2-40B4-BE49-F238E27FC236}">
                      <a16:creationId xmlns:a16="http://schemas.microsoft.com/office/drawing/2014/main" id="{417FA932-0FE2-44AB-AD80-C629514042B9}"/>
                    </a:ext>
                  </a:extLst>
                </p:cNvPr>
                <p:cNvSpPr txBox="1"/>
                <p:nvPr/>
              </p:nvSpPr>
              <p:spPr>
                <a:xfrm>
                  <a:off x="3704770" y="5219282"/>
                  <a:ext cx="486983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HIPP</a:t>
                  </a:r>
                </a:p>
              </p:txBody>
            </p:sp>
            <p:sp>
              <p:nvSpPr>
                <p:cNvPr id="9" name="TextBox 8">
                  <a:extLst>
                    <a:ext uri="{FF2B5EF4-FFF2-40B4-BE49-F238E27FC236}">
                      <a16:creationId xmlns:a16="http://schemas.microsoft.com/office/drawing/2014/main" id="{5125A25D-5585-453C-8FBD-C5B0000C8677}"/>
                    </a:ext>
                  </a:extLst>
                </p:cNvPr>
                <p:cNvSpPr txBox="1"/>
                <p:nvPr/>
              </p:nvSpPr>
              <p:spPr>
                <a:xfrm>
                  <a:off x="3704770" y="5473359"/>
                  <a:ext cx="577518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FC</a:t>
                  </a:r>
                </a:p>
              </p:txBody>
            </p:sp>
            <p:sp>
              <p:nvSpPr>
                <p:cNvPr id="10" name="TextBox 9">
                  <a:extLst>
                    <a:ext uri="{FF2B5EF4-FFF2-40B4-BE49-F238E27FC236}">
                      <a16:creationId xmlns:a16="http://schemas.microsoft.com/office/drawing/2014/main" id="{6DD47B39-BBB8-469A-BE0F-433354D72016}"/>
                    </a:ext>
                  </a:extLst>
                </p:cNvPr>
                <p:cNvSpPr txBox="1"/>
                <p:nvPr/>
              </p:nvSpPr>
              <p:spPr>
                <a:xfrm>
                  <a:off x="3704770" y="5711637"/>
                  <a:ext cx="486983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NAc</a:t>
                  </a:r>
                  <a:endParaRPr lang="en-US" sz="10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F5FCA06D-18DD-4C92-9419-E9D6EF93EED5}"/>
                    </a:ext>
                  </a:extLst>
                </p:cNvPr>
                <p:cNvSpPr txBox="1"/>
                <p:nvPr/>
              </p:nvSpPr>
              <p:spPr>
                <a:xfrm>
                  <a:off x="3704769" y="5949915"/>
                  <a:ext cx="486983" cy="246221"/>
                </a:xfrm>
                <a:prstGeom prst="rect">
                  <a:avLst/>
                </a:prstGeom>
                <a:solidFill>
                  <a:schemeClr val="bg1"/>
                </a:solidFill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VTA</a:t>
                  </a:r>
                </a:p>
              </p:txBody>
            </p:sp>
            <p:pic>
              <p:nvPicPr>
                <p:cNvPr id="12" name="Picture 11" descr="Proteins Quantified in each SampleSet">
                  <a:extLst>
                    <a:ext uri="{FF2B5EF4-FFF2-40B4-BE49-F238E27FC236}">
                      <a16:creationId xmlns:a16="http://schemas.microsoft.com/office/drawing/2014/main" id="{2353BE4C-E9AB-46F9-9AD8-77011F94F2C8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29614"/>
                <a:stretch/>
              </p:blipFill>
              <p:spPr bwMode="auto">
                <a:xfrm>
                  <a:off x="1573793" y="273624"/>
                  <a:ext cx="9044411" cy="4547124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sp>
            <p:nvSpPr>
              <p:cNvPr id="14" name="Rectangle 13">
                <a:extLst>
                  <a:ext uri="{FF2B5EF4-FFF2-40B4-BE49-F238E27FC236}">
                    <a16:creationId xmlns:a16="http://schemas.microsoft.com/office/drawing/2014/main" id="{546F8F24-9AA1-4C70-9A00-F7BBBE66EF6D}"/>
                  </a:ext>
                </a:extLst>
              </p:cNvPr>
              <p:cNvSpPr/>
              <p:nvPr/>
            </p:nvSpPr>
            <p:spPr>
              <a:xfrm>
                <a:off x="4392890" y="4295508"/>
                <a:ext cx="641023" cy="17910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60C2FD7A-5B0C-4B9D-AB0A-B599B869EB24}"/>
                  </a:ext>
                </a:extLst>
              </p:cNvPr>
              <p:cNvSpPr/>
              <p:nvPr/>
            </p:nvSpPr>
            <p:spPr>
              <a:xfrm>
                <a:off x="4721257" y="4359895"/>
                <a:ext cx="475488" cy="179109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9D04D3E5-26A1-42B8-AAEE-B6F0F5F72E50}"/>
                </a:ext>
              </a:extLst>
            </p:cNvPr>
            <p:cNvSpPr txBox="1"/>
            <p:nvPr/>
          </p:nvSpPr>
          <p:spPr>
            <a:xfrm>
              <a:off x="4315904" y="3871807"/>
              <a:ext cx="4754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42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1EA896D0-24C4-4EA8-AC0E-88DC125972F3}"/>
                </a:ext>
              </a:extLst>
            </p:cNvPr>
            <p:cNvSpPr txBox="1"/>
            <p:nvPr/>
          </p:nvSpPr>
          <p:spPr>
            <a:xfrm>
              <a:off x="4465491" y="4025237"/>
              <a:ext cx="4053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212</a:t>
              </a:r>
              <a:endParaRPr lang="en-US" sz="100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8A80EE26-5D5B-42E0-B725-9D47EC9C42BC}"/>
                </a:ext>
              </a:extLst>
            </p:cNvPr>
            <p:cNvSpPr txBox="1"/>
            <p:nvPr/>
          </p:nvSpPr>
          <p:spPr>
            <a:xfrm>
              <a:off x="4621709" y="4166109"/>
              <a:ext cx="4053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161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2E71AD24-29E9-4A59-93C1-64E607C1587C}"/>
                </a:ext>
              </a:extLst>
            </p:cNvPr>
            <p:cNvSpPr txBox="1"/>
            <p:nvPr/>
          </p:nvSpPr>
          <p:spPr>
            <a:xfrm>
              <a:off x="4765925" y="4284056"/>
              <a:ext cx="4053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143</a:t>
              </a:r>
              <a:endParaRPr lang="en-US" sz="1000" dirty="0"/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A992D2BC-FAEA-4A0F-A076-25C9E19594FD}"/>
                </a:ext>
              </a:extLst>
            </p:cNvPr>
            <p:cNvSpPr txBox="1"/>
            <p:nvPr/>
          </p:nvSpPr>
          <p:spPr>
            <a:xfrm>
              <a:off x="4908222" y="4392023"/>
              <a:ext cx="40535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/>
                <a:t>130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9FC389ED-7D8F-2F67-F7EF-A8F0601389B8}"/>
              </a:ext>
            </a:extLst>
          </p:cNvPr>
          <p:cNvSpPr txBox="1"/>
          <p:nvPr/>
        </p:nvSpPr>
        <p:spPr>
          <a:xfrm>
            <a:off x="9179169" y="6550223"/>
            <a:ext cx="3012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1, Teng et al.</a:t>
            </a:r>
          </a:p>
        </p:txBody>
      </p:sp>
    </p:spTree>
    <p:extLst>
      <p:ext uri="{BB962C8B-B14F-4D97-AF65-F5344CB8AC3E}">
        <p14:creationId xmlns:p14="http://schemas.microsoft.com/office/powerpoint/2010/main" val="4726369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B2A9D919-9F11-492E-A42B-DD9474C343C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2240" y="871506"/>
            <a:ext cx="10327519" cy="5114987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81FC3EEE-FE28-FBD4-C3E6-6842C75DDB99}"/>
              </a:ext>
            </a:extLst>
          </p:cNvPr>
          <p:cNvSpPr txBox="1"/>
          <p:nvPr/>
        </p:nvSpPr>
        <p:spPr>
          <a:xfrm>
            <a:off x="9179169" y="6550223"/>
            <a:ext cx="3012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2, Teng et al.</a:t>
            </a:r>
          </a:p>
        </p:txBody>
      </p:sp>
    </p:spTree>
    <p:extLst>
      <p:ext uri="{BB962C8B-B14F-4D97-AF65-F5344CB8AC3E}">
        <p14:creationId xmlns:p14="http://schemas.microsoft.com/office/powerpoint/2010/main" val="13249281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FD538C7A-7E07-445B-BBFC-743F81FC6200}"/>
              </a:ext>
            </a:extLst>
          </p:cNvPr>
          <p:cNvGrpSpPr/>
          <p:nvPr/>
        </p:nvGrpSpPr>
        <p:grpSpPr>
          <a:xfrm>
            <a:off x="1856967" y="1235709"/>
            <a:ext cx="7941162" cy="3849687"/>
            <a:chOff x="1856967" y="1235709"/>
            <a:chExt cx="7941162" cy="3849687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CDE224EC-03E5-44E9-BB2A-C23D1B464621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856967" y="1235709"/>
            <a:ext cx="7158037" cy="384968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76" name="Prism 8" r:id="rId3" imgW="7158057" imgH="3849687" progId="Prism8.Document">
                    <p:embed/>
                  </p:oleObj>
                </mc:Choice>
                <mc:Fallback>
                  <p:oleObj name="Prism 8" r:id="rId3" imgW="7158057" imgH="3849687" progId="Prism8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CDE224EC-03E5-44E9-BB2A-C23D1B464621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856967" y="1235709"/>
                          <a:ext cx="7158037" cy="3849687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894323F-23CF-410A-A9B4-0C071D482521}"/>
                </a:ext>
              </a:extLst>
            </p:cNvPr>
            <p:cNvSpPr txBox="1"/>
            <p:nvPr/>
          </p:nvSpPr>
          <p:spPr>
            <a:xfrm>
              <a:off x="8231879" y="4777619"/>
              <a:ext cx="15662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-log(p-value)</a:t>
              </a:r>
            </a:p>
          </p:txBody>
        </p:sp>
      </p:grpSp>
      <p:sp>
        <p:nvSpPr>
          <p:cNvPr id="6" name="TextBox 5">
            <a:extLst>
              <a:ext uri="{FF2B5EF4-FFF2-40B4-BE49-F238E27FC236}">
                <a16:creationId xmlns:a16="http://schemas.microsoft.com/office/drawing/2014/main" id="{5DB0D784-8C1A-76FB-C580-9668E3F16A13}"/>
              </a:ext>
            </a:extLst>
          </p:cNvPr>
          <p:cNvSpPr txBox="1"/>
          <p:nvPr/>
        </p:nvSpPr>
        <p:spPr>
          <a:xfrm>
            <a:off x="9179169" y="6550223"/>
            <a:ext cx="30128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Fig. 3, Teng et al.</a:t>
            </a:r>
          </a:p>
        </p:txBody>
      </p:sp>
    </p:spTree>
    <p:extLst>
      <p:ext uri="{BB962C8B-B14F-4D97-AF65-F5344CB8AC3E}">
        <p14:creationId xmlns:p14="http://schemas.microsoft.com/office/powerpoint/2010/main" val="348207533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3</Words>
  <Application>Microsoft Office PowerPoint</Application>
  <PresentationFormat>Widescreen</PresentationFormat>
  <Paragraphs>15</Paragraphs>
  <Slides>3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onnie Teng</dc:creator>
  <cp:lastModifiedBy>Bonnie Teng</cp:lastModifiedBy>
  <cp:revision>4</cp:revision>
  <dcterms:created xsi:type="dcterms:W3CDTF">2023-05-15T17:44:29Z</dcterms:created>
  <dcterms:modified xsi:type="dcterms:W3CDTF">2023-05-16T14:25:34Z</dcterms:modified>
</cp:coreProperties>
</file>